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248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392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747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195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799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166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83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31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683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960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437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940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1A5A5-DE23-432B-808D-CA6EF9D1514A}" type="datetimeFigureOut">
              <a:rPr lang="en-US" smtClean="0"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B43911-66F8-44C7-A7FC-04E7B0388F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47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F9F5326-6601-4734-8B9E-99E2A4A73963}"/>
              </a:ext>
            </a:extLst>
          </p:cNvPr>
          <p:cNvSpPr txBox="1"/>
          <p:nvPr/>
        </p:nvSpPr>
        <p:spPr>
          <a:xfrm rot="17707202">
            <a:off x="788124" y="1200810"/>
            <a:ext cx="12907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ock </a:t>
            </a:r>
          </a:p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ransfecte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DA608C-2000-45FA-BC35-FFD5B2235254}"/>
              </a:ext>
            </a:extLst>
          </p:cNvPr>
          <p:cNvSpPr txBox="1"/>
          <p:nvPr/>
        </p:nvSpPr>
        <p:spPr>
          <a:xfrm rot="17707202">
            <a:off x="1572287" y="1348823"/>
            <a:ext cx="14093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cDNA3.1(+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73F9387-8746-48BA-9702-74A2EE566170}"/>
              </a:ext>
            </a:extLst>
          </p:cNvPr>
          <p:cNvSpPr txBox="1"/>
          <p:nvPr/>
        </p:nvSpPr>
        <p:spPr>
          <a:xfrm rot="17707202">
            <a:off x="2299226" y="1251531"/>
            <a:ext cx="1595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ARS-CoV-2 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09B883C-853E-4546-A1E2-4D2A94A37010}"/>
              </a:ext>
            </a:extLst>
          </p:cNvPr>
          <p:cNvSpPr txBox="1"/>
          <p:nvPr/>
        </p:nvSpPr>
        <p:spPr>
          <a:xfrm rot="17707202">
            <a:off x="4693619" y="1312660"/>
            <a:ext cx="14237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ARS-CoV 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39D2E88-DFE9-4520-AB4D-9DB98BA45903}"/>
              </a:ext>
            </a:extLst>
          </p:cNvPr>
          <p:cNvSpPr txBox="1"/>
          <p:nvPr/>
        </p:nvSpPr>
        <p:spPr>
          <a:xfrm rot="17707202">
            <a:off x="3828243" y="1326811"/>
            <a:ext cx="14478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ERS-CoV 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E71530-9E95-4738-BE30-25FEF5EC73B8}"/>
              </a:ext>
            </a:extLst>
          </p:cNvPr>
          <p:cNvSpPr txBox="1"/>
          <p:nvPr/>
        </p:nvSpPr>
        <p:spPr>
          <a:xfrm rot="17707202">
            <a:off x="3075782" y="1282010"/>
            <a:ext cx="15278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CoV-OC43 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C4475C0-E359-42DF-86C3-494C3A3AC837}"/>
              </a:ext>
            </a:extLst>
          </p:cNvPr>
          <p:cNvSpPr txBox="1"/>
          <p:nvPr/>
        </p:nvSpPr>
        <p:spPr>
          <a:xfrm>
            <a:off x="5835590" y="2504123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C3-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E623BB-2667-4FBE-BE0A-D5AC2447FA75}"/>
              </a:ext>
            </a:extLst>
          </p:cNvPr>
          <p:cNvSpPr txBox="1"/>
          <p:nvPr/>
        </p:nvSpPr>
        <p:spPr>
          <a:xfrm>
            <a:off x="5879374" y="2786149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C3-I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E554F4-CBA8-492B-801B-135738D09DC1}"/>
              </a:ext>
            </a:extLst>
          </p:cNvPr>
          <p:cNvSpPr txBox="1"/>
          <p:nvPr/>
        </p:nvSpPr>
        <p:spPr>
          <a:xfrm rot="17707202">
            <a:off x="762723" y="4929051"/>
            <a:ext cx="12907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ock </a:t>
            </a:r>
          </a:p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ransfecte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602CFE8-90EE-400C-B902-AAD0A798DC4B}"/>
              </a:ext>
            </a:extLst>
          </p:cNvPr>
          <p:cNvSpPr txBox="1"/>
          <p:nvPr/>
        </p:nvSpPr>
        <p:spPr>
          <a:xfrm rot="17707202">
            <a:off x="1546886" y="5077064"/>
            <a:ext cx="14093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cDNA3.1(+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A91E9B9-12AC-484F-AF43-4045860DC566}"/>
              </a:ext>
            </a:extLst>
          </p:cNvPr>
          <p:cNvSpPr txBox="1"/>
          <p:nvPr/>
        </p:nvSpPr>
        <p:spPr>
          <a:xfrm rot="17707202">
            <a:off x="2273825" y="4979772"/>
            <a:ext cx="1595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ARS-CoV-2 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C028AC1-FBFF-4571-861E-374AD621A7CB}"/>
              </a:ext>
            </a:extLst>
          </p:cNvPr>
          <p:cNvSpPr txBox="1"/>
          <p:nvPr/>
        </p:nvSpPr>
        <p:spPr>
          <a:xfrm rot="17707202">
            <a:off x="4668218" y="5040901"/>
            <a:ext cx="14237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ARS-CoV 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4C30E9-855C-4D21-BA95-CA70B037E43B}"/>
              </a:ext>
            </a:extLst>
          </p:cNvPr>
          <p:cNvSpPr txBox="1"/>
          <p:nvPr/>
        </p:nvSpPr>
        <p:spPr>
          <a:xfrm rot="17707202">
            <a:off x="3802842" y="5055052"/>
            <a:ext cx="14478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ERS-CoV 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A4158C5-9895-4977-B4B7-0174FA988A36}"/>
              </a:ext>
            </a:extLst>
          </p:cNvPr>
          <p:cNvSpPr txBox="1"/>
          <p:nvPr/>
        </p:nvSpPr>
        <p:spPr>
          <a:xfrm rot="17707202">
            <a:off x="3050381" y="5010251"/>
            <a:ext cx="15278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CoV-OC43 E</a:t>
            </a:r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8FEED2DB-1ACB-45FA-B9B4-7CC495D0B89E}"/>
              </a:ext>
            </a:extLst>
          </p:cNvPr>
          <p:cNvSpPr/>
          <p:nvPr/>
        </p:nvSpPr>
        <p:spPr>
          <a:xfrm rot="16200000">
            <a:off x="5522594" y="6487227"/>
            <a:ext cx="225698" cy="28114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AB84B7D-1159-4058-A858-AA5E3C5DDB9E}"/>
              </a:ext>
            </a:extLst>
          </p:cNvPr>
          <p:cNvSpPr txBox="1"/>
          <p:nvPr/>
        </p:nvSpPr>
        <p:spPr>
          <a:xfrm>
            <a:off x="609600" y="101600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BD353FD-349D-48B8-9C03-7A2EF40FE890}"/>
              </a:ext>
            </a:extLst>
          </p:cNvPr>
          <p:cNvSpPr txBox="1"/>
          <p:nvPr/>
        </p:nvSpPr>
        <p:spPr>
          <a:xfrm>
            <a:off x="597281" y="502439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30" name="Isosceles Triangle 29">
            <a:extLst>
              <a:ext uri="{FF2B5EF4-FFF2-40B4-BE49-F238E27FC236}">
                <a16:creationId xmlns:a16="http://schemas.microsoft.com/office/drawing/2014/main" id="{B150B588-07F5-49F9-B672-BA878C10CDCF}"/>
              </a:ext>
            </a:extLst>
          </p:cNvPr>
          <p:cNvSpPr/>
          <p:nvPr/>
        </p:nvSpPr>
        <p:spPr>
          <a:xfrm rot="16200000">
            <a:off x="5562865" y="2536351"/>
            <a:ext cx="225698" cy="28114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Isosceles Triangle 30">
            <a:extLst>
              <a:ext uri="{FF2B5EF4-FFF2-40B4-BE49-F238E27FC236}">
                <a16:creationId xmlns:a16="http://schemas.microsoft.com/office/drawing/2014/main" id="{2CA00B7C-823D-444E-A641-25B58397FB2D}"/>
              </a:ext>
            </a:extLst>
          </p:cNvPr>
          <p:cNvSpPr/>
          <p:nvPr/>
        </p:nvSpPr>
        <p:spPr>
          <a:xfrm rot="16200000">
            <a:off x="5582170" y="2774647"/>
            <a:ext cx="225698" cy="281142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93BF0B9-A1C9-466E-A4F6-4729491695D8}"/>
              </a:ext>
            </a:extLst>
          </p:cNvPr>
          <p:cNvSpPr txBox="1"/>
          <p:nvPr/>
        </p:nvSpPr>
        <p:spPr>
          <a:xfrm>
            <a:off x="6033628" y="636494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15692C5-40C4-442B-A669-E91EF412DFDC}"/>
              </a:ext>
            </a:extLst>
          </p:cNvPr>
          <p:cNvSpPr txBox="1"/>
          <p:nvPr/>
        </p:nvSpPr>
        <p:spPr>
          <a:xfrm>
            <a:off x="213382" y="8551774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le 6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78766AF1-35D8-441D-B495-72D2C53653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4129" y="2227923"/>
            <a:ext cx="4579030" cy="1361872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1B7658C-26B7-430B-907A-C1902EC7EFDD}"/>
              </a:ext>
            </a:extLst>
          </p:cNvPr>
          <p:cNvSpPr/>
          <p:nvPr/>
        </p:nvSpPr>
        <p:spPr>
          <a:xfrm>
            <a:off x="894789" y="2227992"/>
            <a:ext cx="4600083" cy="1361803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1BD9919-026A-4310-9444-3885013D465C}"/>
              </a:ext>
            </a:extLst>
          </p:cNvPr>
          <p:cNvSpPr txBox="1"/>
          <p:nvPr/>
        </p:nvSpPr>
        <p:spPr>
          <a:xfrm>
            <a:off x="294099" y="621105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9421015-4F01-4902-9D5A-31D0B41D6DA1}"/>
              </a:ext>
            </a:extLst>
          </p:cNvPr>
          <p:cNvSpPr txBox="1"/>
          <p:nvPr/>
        </p:nvSpPr>
        <p:spPr>
          <a:xfrm>
            <a:off x="290043" y="673427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grpSp>
        <p:nvGrpSpPr>
          <p:cNvPr id="37" name="Group 4">
            <a:extLst>
              <a:ext uri="{FF2B5EF4-FFF2-40B4-BE49-F238E27FC236}">
                <a16:creationId xmlns:a16="http://schemas.microsoft.com/office/drawing/2014/main" id="{18F3EC28-4622-49DC-AE6B-2A0CDECE381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834816" y="6020762"/>
            <a:ext cx="4654550" cy="1157288"/>
            <a:chOff x="555" y="3822"/>
            <a:chExt cx="2932" cy="729"/>
          </a:xfrm>
        </p:grpSpPr>
        <p:sp>
          <p:nvSpPr>
            <p:cNvPr id="38" name="AutoShape 3">
              <a:extLst>
                <a:ext uri="{FF2B5EF4-FFF2-40B4-BE49-F238E27FC236}">
                  <a16:creationId xmlns:a16="http://schemas.microsoft.com/office/drawing/2014/main" id="{3F687BD8-8D55-48F4-845A-9D9AD98324B5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555" y="3822"/>
              <a:ext cx="2932" cy="7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1029" name="Picture 5">
              <a:extLst>
                <a:ext uri="{FF2B5EF4-FFF2-40B4-BE49-F238E27FC236}">
                  <a16:creationId xmlns:a16="http://schemas.microsoft.com/office/drawing/2014/main" id="{AA930D65-74BD-43D8-9454-BA0B0DBD190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5" y="3822"/>
              <a:ext cx="2927" cy="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C63177C8-15BD-484F-9147-ECB2CA6CE3D0}"/>
              </a:ext>
            </a:extLst>
          </p:cNvPr>
          <p:cNvCxnSpPr>
            <a:cxnSpLocks/>
          </p:cNvCxnSpPr>
          <p:nvPr/>
        </p:nvCxnSpPr>
        <p:spPr>
          <a:xfrm>
            <a:off x="663947" y="6364943"/>
            <a:ext cx="24018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3279E1E1-68B2-472B-B615-45497F556A96}"/>
              </a:ext>
            </a:extLst>
          </p:cNvPr>
          <p:cNvCxnSpPr>
            <a:cxnSpLocks/>
          </p:cNvCxnSpPr>
          <p:nvPr/>
        </p:nvCxnSpPr>
        <p:spPr>
          <a:xfrm>
            <a:off x="632460" y="6897370"/>
            <a:ext cx="24018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1E84C842-00DF-480B-9CBF-91813EFCCFBF}"/>
              </a:ext>
            </a:extLst>
          </p:cNvPr>
          <p:cNvCxnSpPr>
            <a:cxnSpLocks/>
          </p:cNvCxnSpPr>
          <p:nvPr/>
        </p:nvCxnSpPr>
        <p:spPr>
          <a:xfrm>
            <a:off x="5515352" y="2370023"/>
            <a:ext cx="24018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F2C47D81-FE81-453A-8680-B154F57B2811}"/>
              </a:ext>
            </a:extLst>
          </p:cNvPr>
          <p:cNvSpPr txBox="1"/>
          <p:nvPr/>
        </p:nvSpPr>
        <p:spPr>
          <a:xfrm>
            <a:off x="5702082" y="220714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7C8FCF9-4EEF-4A33-A155-B320C68DF9D1}"/>
              </a:ext>
            </a:extLst>
          </p:cNvPr>
          <p:cNvSpPr txBox="1"/>
          <p:nvPr/>
        </p:nvSpPr>
        <p:spPr>
          <a:xfrm>
            <a:off x="2790072" y="724257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  <a:endParaRPr lang="en-US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1D5AD00-3B8A-4B99-967C-9EE5F7AA7C8D}"/>
              </a:ext>
            </a:extLst>
          </p:cNvPr>
          <p:cNvSpPr txBox="1"/>
          <p:nvPr/>
        </p:nvSpPr>
        <p:spPr>
          <a:xfrm>
            <a:off x="2785643" y="3693789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-LC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896514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</TotalTime>
  <Words>42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Stephens</dc:creator>
  <cp:lastModifiedBy>Edward Stephens</cp:lastModifiedBy>
  <cp:revision>8</cp:revision>
  <dcterms:created xsi:type="dcterms:W3CDTF">2022-09-13T20:21:02Z</dcterms:created>
  <dcterms:modified xsi:type="dcterms:W3CDTF">2022-10-17T15:08:19Z</dcterms:modified>
</cp:coreProperties>
</file>